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notesMasterIdLst>
    <p:notesMasterId r:id="rId3"/>
  </p:notesMasterIdLst>
  <p:sldIdLst>
    <p:sldId id="282" r:id="rId2"/>
  </p:sldIdLst>
  <p:sldSz cx="6627813" cy="8229600"/>
  <p:notesSz cx="6797675" cy="9926638"/>
  <p:defaultTextStyle>
    <a:defPPr>
      <a:defRPr lang="en-US"/>
    </a:defPPr>
    <a:lvl1pPr marL="0" algn="l" defTabSz="931682" rtl="0" eaLnBrk="1" latinLnBrk="0" hangingPunct="1">
      <a:defRPr sz="1834" kern="1200">
        <a:solidFill>
          <a:schemeClr val="tx1"/>
        </a:solidFill>
        <a:latin typeface="+mn-lt"/>
        <a:ea typeface="+mn-ea"/>
        <a:cs typeface="+mn-cs"/>
      </a:defRPr>
    </a:lvl1pPr>
    <a:lvl2pPr marL="465841" algn="l" defTabSz="931682" rtl="0" eaLnBrk="1" latinLnBrk="0" hangingPunct="1">
      <a:defRPr sz="1834" kern="1200">
        <a:solidFill>
          <a:schemeClr val="tx1"/>
        </a:solidFill>
        <a:latin typeface="+mn-lt"/>
        <a:ea typeface="+mn-ea"/>
        <a:cs typeface="+mn-cs"/>
      </a:defRPr>
    </a:lvl2pPr>
    <a:lvl3pPr marL="931682" algn="l" defTabSz="931682" rtl="0" eaLnBrk="1" latinLnBrk="0" hangingPunct="1">
      <a:defRPr sz="1834" kern="1200">
        <a:solidFill>
          <a:schemeClr val="tx1"/>
        </a:solidFill>
        <a:latin typeface="+mn-lt"/>
        <a:ea typeface="+mn-ea"/>
        <a:cs typeface="+mn-cs"/>
      </a:defRPr>
    </a:lvl3pPr>
    <a:lvl4pPr marL="1397523" algn="l" defTabSz="931682" rtl="0" eaLnBrk="1" latinLnBrk="0" hangingPunct="1">
      <a:defRPr sz="1834" kern="1200">
        <a:solidFill>
          <a:schemeClr val="tx1"/>
        </a:solidFill>
        <a:latin typeface="+mn-lt"/>
        <a:ea typeface="+mn-ea"/>
        <a:cs typeface="+mn-cs"/>
      </a:defRPr>
    </a:lvl4pPr>
    <a:lvl5pPr marL="1863364" algn="l" defTabSz="931682" rtl="0" eaLnBrk="1" latinLnBrk="0" hangingPunct="1">
      <a:defRPr sz="1834" kern="1200">
        <a:solidFill>
          <a:schemeClr val="tx1"/>
        </a:solidFill>
        <a:latin typeface="+mn-lt"/>
        <a:ea typeface="+mn-ea"/>
        <a:cs typeface="+mn-cs"/>
      </a:defRPr>
    </a:lvl5pPr>
    <a:lvl6pPr marL="2329205" algn="l" defTabSz="931682" rtl="0" eaLnBrk="1" latinLnBrk="0" hangingPunct="1">
      <a:defRPr sz="1834" kern="1200">
        <a:solidFill>
          <a:schemeClr val="tx1"/>
        </a:solidFill>
        <a:latin typeface="+mn-lt"/>
        <a:ea typeface="+mn-ea"/>
        <a:cs typeface="+mn-cs"/>
      </a:defRPr>
    </a:lvl6pPr>
    <a:lvl7pPr marL="2795046" algn="l" defTabSz="931682" rtl="0" eaLnBrk="1" latinLnBrk="0" hangingPunct="1">
      <a:defRPr sz="1834" kern="1200">
        <a:solidFill>
          <a:schemeClr val="tx1"/>
        </a:solidFill>
        <a:latin typeface="+mn-lt"/>
        <a:ea typeface="+mn-ea"/>
        <a:cs typeface="+mn-cs"/>
      </a:defRPr>
    </a:lvl7pPr>
    <a:lvl8pPr marL="3260888" algn="l" defTabSz="931682" rtl="0" eaLnBrk="1" latinLnBrk="0" hangingPunct="1">
      <a:defRPr sz="1834" kern="1200">
        <a:solidFill>
          <a:schemeClr val="tx1"/>
        </a:solidFill>
        <a:latin typeface="+mn-lt"/>
        <a:ea typeface="+mn-ea"/>
        <a:cs typeface="+mn-cs"/>
      </a:defRPr>
    </a:lvl8pPr>
    <a:lvl9pPr marL="3726729" algn="l" defTabSz="931682" rtl="0" eaLnBrk="1" latinLnBrk="0" hangingPunct="1">
      <a:defRPr sz="1834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569" autoAdjust="0"/>
    <p:restoredTop sz="88977" autoAdjust="0"/>
  </p:normalViewPr>
  <p:slideViewPr>
    <p:cSldViewPr snapToGrid="0">
      <p:cViewPr varScale="1">
        <p:scale>
          <a:sx n="68" d="100"/>
          <a:sy n="68" d="100"/>
        </p:scale>
        <p:origin x="73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60" cy="498056"/>
          </a:xfrm>
          <a:prstGeom prst="rect">
            <a:avLst/>
          </a:prstGeom>
        </p:spPr>
        <p:txBody>
          <a:bodyPr vert="horz" lIns="91361" tIns="45681" rIns="91361" bIns="45681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60" cy="498056"/>
          </a:xfrm>
          <a:prstGeom prst="rect">
            <a:avLst/>
          </a:prstGeom>
        </p:spPr>
        <p:txBody>
          <a:bodyPr vert="horz" lIns="91361" tIns="45681" rIns="91361" bIns="45681" rtlCol="0"/>
          <a:lstStyle>
            <a:lvl1pPr algn="r">
              <a:defRPr sz="1200"/>
            </a:lvl1pPr>
          </a:lstStyle>
          <a:p>
            <a:fld id="{C5D40AFF-1C51-4ABB-BD6B-D0EE3408014B}" type="datetimeFigureOut">
              <a:rPr lang="en-US" smtClean="0"/>
              <a:t>12/5/2017</a:t>
            </a:fld>
            <a:endParaRPr 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049463" y="1241425"/>
            <a:ext cx="2698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361" tIns="45681" rIns="91361" bIns="45681" rtlCol="0" anchor="ctr"/>
          <a:lstStyle/>
          <a:p>
            <a:endParaRPr 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9768" y="4777195"/>
            <a:ext cx="5438140" cy="3908614"/>
          </a:xfrm>
          <a:prstGeom prst="rect">
            <a:avLst/>
          </a:prstGeom>
        </p:spPr>
        <p:txBody>
          <a:bodyPr vert="horz" lIns="91361" tIns="45681" rIns="91361" bIns="45681" rtlCol="0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60" cy="498055"/>
          </a:xfrm>
          <a:prstGeom prst="rect">
            <a:avLst/>
          </a:prstGeom>
        </p:spPr>
        <p:txBody>
          <a:bodyPr vert="horz" lIns="91361" tIns="45681" rIns="91361" bIns="45681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60" cy="498055"/>
          </a:xfrm>
          <a:prstGeom prst="rect">
            <a:avLst/>
          </a:prstGeom>
        </p:spPr>
        <p:txBody>
          <a:bodyPr vert="horz" lIns="91361" tIns="45681" rIns="91361" bIns="45681" rtlCol="0" anchor="b"/>
          <a:lstStyle>
            <a:lvl1pPr algn="r">
              <a:defRPr sz="1200"/>
            </a:lvl1pPr>
          </a:lstStyle>
          <a:p>
            <a:fld id="{63E91E67-22E1-4F8C-A6ED-04C89FD848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551597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31682" rtl="0" eaLnBrk="1" latinLnBrk="0" hangingPunct="1">
      <a:defRPr sz="1223" kern="1200">
        <a:solidFill>
          <a:schemeClr val="tx1"/>
        </a:solidFill>
        <a:latin typeface="+mn-lt"/>
        <a:ea typeface="+mn-ea"/>
        <a:cs typeface="+mn-cs"/>
      </a:defRPr>
    </a:lvl1pPr>
    <a:lvl2pPr marL="465841" algn="l" defTabSz="931682" rtl="0" eaLnBrk="1" latinLnBrk="0" hangingPunct="1">
      <a:defRPr sz="1223" kern="1200">
        <a:solidFill>
          <a:schemeClr val="tx1"/>
        </a:solidFill>
        <a:latin typeface="+mn-lt"/>
        <a:ea typeface="+mn-ea"/>
        <a:cs typeface="+mn-cs"/>
      </a:defRPr>
    </a:lvl2pPr>
    <a:lvl3pPr marL="931682" algn="l" defTabSz="931682" rtl="0" eaLnBrk="1" latinLnBrk="0" hangingPunct="1">
      <a:defRPr sz="1223" kern="1200">
        <a:solidFill>
          <a:schemeClr val="tx1"/>
        </a:solidFill>
        <a:latin typeface="+mn-lt"/>
        <a:ea typeface="+mn-ea"/>
        <a:cs typeface="+mn-cs"/>
      </a:defRPr>
    </a:lvl3pPr>
    <a:lvl4pPr marL="1397523" algn="l" defTabSz="931682" rtl="0" eaLnBrk="1" latinLnBrk="0" hangingPunct="1">
      <a:defRPr sz="1223" kern="1200">
        <a:solidFill>
          <a:schemeClr val="tx1"/>
        </a:solidFill>
        <a:latin typeface="+mn-lt"/>
        <a:ea typeface="+mn-ea"/>
        <a:cs typeface="+mn-cs"/>
      </a:defRPr>
    </a:lvl4pPr>
    <a:lvl5pPr marL="1863364" algn="l" defTabSz="931682" rtl="0" eaLnBrk="1" latinLnBrk="0" hangingPunct="1">
      <a:defRPr sz="1223" kern="1200">
        <a:solidFill>
          <a:schemeClr val="tx1"/>
        </a:solidFill>
        <a:latin typeface="+mn-lt"/>
        <a:ea typeface="+mn-ea"/>
        <a:cs typeface="+mn-cs"/>
      </a:defRPr>
    </a:lvl5pPr>
    <a:lvl6pPr marL="2329205" algn="l" defTabSz="931682" rtl="0" eaLnBrk="1" latinLnBrk="0" hangingPunct="1">
      <a:defRPr sz="1223" kern="1200">
        <a:solidFill>
          <a:schemeClr val="tx1"/>
        </a:solidFill>
        <a:latin typeface="+mn-lt"/>
        <a:ea typeface="+mn-ea"/>
        <a:cs typeface="+mn-cs"/>
      </a:defRPr>
    </a:lvl6pPr>
    <a:lvl7pPr marL="2795046" algn="l" defTabSz="931682" rtl="0" eaLnBrk="1" latinLnBrk="0" hangingPunct="1">
      <a:defRPr sz="1223" kern="1200">
        <a:solidFill>
          <a:schemeClr val="tx1"/>
        </a:solidFill>
        <a:latin typeface="+mn-lt"/>
        <a:ea typeface="+mn-ea"/>
        <a:cs typeface="+mn-cs"/>
      </a:defRPr>
    </a:lvl7pPr>
    <a:lvl8pPr marL="3260888" algn="l" defTabSz="931682" rtl="0" eaLnBrk="1" latinLnBrk="0" hangingPunct="1">
      <a:defRPr sz="1223" kern="1200">
        <a:solidFill>
          <a:schemeClr val="tx1"/>
        </a:solidFill>
        <a:latin typeface="+mn-lt"/>
        <a:ea typeface="+mn-ea"/>
        <a:cs typeface="+mn-cs"/>
      </a:defRPr>
    </a:lvl8pPr>
    <a:lvl9pPr marL="3726729" algn="l" defTabSz="931682" rtl="0" eaLnBrk="1" latinLnBrk="0" hangingPunct="1">
      <a:defRPr sz="1223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97086" y="1346836"/>
            <a:ext cx="5633641" cy="2865120"/>
          </a:xfrm>
        </p:spPr>
        <p:txBody>
          <a:bodyPr anchor="b"/>
          <a:lstStyle>
            <a:lvl1pPr algn="ctr">
              <a:defRPr sz="4349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28477" y="4322446"/>
            <a:ext cx="4970860" cy="1986914"/>
          </a:xfrm>
        </p:spPr>
        <p:txBody>
          <a:bodyPr/>
          <a:lstStyle>
            <a:lvl1pPr marL="0" indent="0" algn="ctr">
              <a:buNone/>
              <a:defRPr sz="1740"/>
            </a:lvl1pPr>
            <a:lvl2pPr marL="331379" indent="0" algn="ctr">
              <a:buNone/>
              <a:defRPr sz="1450"/>
            </a:lvl2pPr>
            <a:lvl3pPr marL="662757" indent="0" algn="ctr">
              <a:buNone/>
              <a:defRPr sz="1305"/>
            </a:lvl3pPr>
            <a:lvl4pPr marL="994136" indent="0" algn="ctr">
              <a:buNone/>
              <a:defRPr sz="1160"/>
            </a:lvl4pPr>
            <a:lvl5pPr marL="1325514" indent="0" algn="ctr">
              <a:buNone/>
              <a:defRPr sz="1160"/>
            </a:lvl5pPr>
            <a:lvl6pPr marL="1656893" indent="0" algn="ctr">
              <a:buNone/>
              <a:defRPr sz="1160"/>
            </a:lvl6pPr>
            <a:lvl7pPr marL="1988271" indent="0" algn="ctr">
              <a:buNone/>
              <a:defRPr sz="1160"/>
            </a:lvl7pPr>
            <a:lvl8pPr marL="2319650" indent="0" algn="ctr">
              <a:buNone/>
              <a:defRPr sz="1160"/>
            </a:lvl8pPr>
            <a:lvl9pPr marL="2651028" indent="0" algn="ctr">
              <a:buNone/>
              <a:defRPr sz="116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ED039-0B3E-4935-8025-9FA77E41070A}" type="datetimeFigureOut">
              <a:rPr lang="en-US" smtClean="0"/>
              <a:t>12/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EC0E46-4EA7-48F4-AD53-1E8331C089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5368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ED039-0B3E-4935-8025-9FA77E41070A}" type="datetimeFigureOut">
              <a:rPr lang="en-US" smtClean="0"/>
              <a:t>12/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EC0E46-4EA7-48F4-AD53-1E8331C089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78767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743029" y="438150"/>
            <a:ext cx="1429122" cy="6974206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5662" y="438150"/>
            <a:ext cx="4204519" cy="6974206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ED039-0B3E-4935-8025-9FA77E41070A}" type="datetimeFigureOut">
              <a:rPr lang="en-US" smtClean="0"/>
              <a:t>12/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EC0E46-4EA7-48F4-AD53-1E8331C089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46585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ED039-0B3E-4935-8025-9FA77E41070A}" type="datetimeFigureOut">
              <a:rPr lang="en-US" smtClean="0"/>
              <a:t>12/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EC0E46-4EA7-48F4-AD53-1E8331C089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2522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2210" y="2051688"/>
            <a:ext cx="5716489" cy="3423284"/>
          </a:xfrm>
        </p:spPr>
        <p:txBody>
          <a:bodyPr anchor="b"/>
          <a:lstStyle>
            <a:lvl1pPr>
              <a:defRPr sz="4349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2210" y="5507358"/>
            <a:ext cx="5716489" cy="1800224"/>
          </a:xfrm>
        </p:spPr>
        <p:txBody>
          <a:bodyPr/>
          <a:lstStyle>
            <a:lvl1pPr marL="0" indent="0">
              <a:buNone/>
              <a:defRPr sz="1740">
                <a:solidFill>
                  <a:schemeClr val="tx1"/>
                </a:solidFill>
              </a:defRPr>
            </a:lvl1pPr>
            <a:lvl2pPr marL="331379" indent="0">
              <a:buNone/>
              <a:defRPr sz="1450">
                <a:solidFill>
                  <a:schemeClr val="tx1">
                    <a:tint val="75000"/>
                  </a:schemeClr>
                </a:solidFill>
              </a:defRPr>
            </a:lvl2pPr>
            <a:lvl3pPr marL="662757" indent="0">
              <a:buNone/>
              <a:defRPr sz="1305">
                <a:solidFill>
                  <a:schemeClr val="tx1">
                    <a:tint val="75000"/>
                  </a:schemeClr>
                </a:solidFill>
              </a:defRPr>
            </a:lvl3pPr>
            <a:lvl4pPr marL="994136" indent="0">
              <a:buNone/>
              <a:defRPr sz="1160">
                <a:solidFill>
                  <a:schemeClr val="tx1">
                    <a:tint val="75000"/>
                  </a:schemeClr>
                </a:solidFill>
              </a:defRPr>
            </a:lvl4pPr>
            <a:lvl5pPr marL="1325514" indent="0">
              <a:buNone/>
              <a:defRPr sz="1160">
                <a:solidFill>
                  <a:schemeClr val="tx1">
                    <a:tint val="75000"/>
                  </a:schemeClr>
                </a:solidFill>
              </a:defRPr>
            </a:lvl5pPr>
            <a:lvl6pPr marL="1656893" indent="0">
              <a:buNone/>
              <a:defRPr sz="1160">
                <a:solidFill>
                  <a:schemeClr val="tx1">
                    <a:tint val="75000"/>
                  </a:schemeClr>
                </a:solidFill>
              </a:defRPr>
            </a:lvl6pPr>
            <a:lvl7pPr marL="1988271" indent="0">
              <a:buNone/>
              <a:defRPr sz="1160">
                <a:solidFill>
                  <a:schemeClr val="tx1">
                    <a:tint val="75000"/>
                  </a:schemeClr>
                </a:solidFill>
              </a:defRPr>
            </a:lvl7pPr>
            <a:lvl8pPr marL="2319650" indent="0">
              <a:buNone/>
              <a:defRPr sz="1160">
                <a:solidFill>
                  <a:schemeClr val="tx1">
                    <a:tint val="75000"/>
                  </a:schemeClr>
                </a:solidFill>
              </a:defRPr>
            </a:lvl8pPr>
            <a:lvl9pPr marL="2651028" indent="0">
              <a:buNone/>
              <a:defRPr sz="11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ED039-0B3E-4935-8025-9FA77E41070A}" type="datetimeFigureOut">
              <a:rPr lang="en-US" smtClean="0"/>
              <a:t>12/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EC0E46-4EA7-48F4-AD53-1E8331C089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44082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5662" y="2190750"/>
            <a:ext cx="2816821" cy="522160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355330" y="2190750"/>
            <a:ext cx="2816821" cy="522160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ED039-0B3E-4935-8025-9FA77E41070A}" type="datetimeFigureOut">
              <a:rPr lang="en-US" smtClean="0"/>
              <a:t>12/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EC0E46-4EA7-48F4-AD53-1E8331C089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72578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6525" y="438152"/>
            <a:ext cx="5716489" cy="1590676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6526" y="2017396"/>
            <a:ext cx="2803875" cy="988694"/>
          </a:xfrm>
        </p:spPr>
        <p:txBody>
          <a:bodyPr anchor="b"/>
          <a:lstStyle>
            <a:lvl1pPr marL="0" indent="0">
              <a:buNone/>
              <a:defRPr sz="1740" b="1"/>
            </a:lvl1pPr>
            <a:lvl2pPr marL="331379" indent="0">
              <a:buNone/>
              <a:defRPr sz="1450" b="1"/>
            </a:lvl2pPr>
            <a:lvl3pPr marL="662757" indent="0">
              <a:buNone/>
              <a:defRPr sz="1305" b="1"/>
            </a:lvl3pPr>
            <a:lvl4pPr marL="994136" indent="0">
              <a:buNone/>
              <a:defRPr sz="1160" b="1"/>
            </a:lvl4pPr>
            <a:lvl5pPr marL="1325514" indent="0">
              <a:buNone/>
              <a:defRPr sz="1160" b="1"/>
            </a:lvl5pPr>
            <a:lvl6pPr marL="1656893" indent="0">
              <a:buNone/>
              <a:defRPr sz="1160" b="1"/>
            </a:lvl6pPr>
            <a:lvl7pPr marL="1988271" indent="0">
              <a:buNone/>
              <a:defRPr sz="1160" b="1"/>
            </a:lvl7pPr>
            <a:lvl8pPr marL="2319650" indent="0">
              <a:buNone/>
              <a:defRPr sz="1160" b="1"/>
            </a:lvl8pPr>
            <a:lvl9pPr marL="2651028" indent="0">
              <a:buNone/>
              <a:defRPr sz="116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6526" y="3006090"/>
            <a:ext cx="2803875" cy="442150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355331" y="2017396"/>
            <a:ext cx="2817684" cy="988694"/>
          </a:xfrm>
        </p:spPr>
        <p:txBody>
          <a:bodyPr anchor="b"/>
          <a:lstStyle>
            <a:lvl1pPr marL="0" indent="0">
              <a:buNone/>
              <a:defRPr sz="1740" b="1"/>
            </a:lvl1pPr>
            <a:lvl2pPr marL="331379" indent="0">
              <a:buNone/>
              <a:defRPr sz="1450" b="1"/>
            </a:lvl2pPr>
            <a:lvl3pPr marL="662757" indent="0">
              <a:buNone/>
              <a:defRPr sz="1305" b="1"/>
            </a:lvl3pPr>
            <a:lvl4pPr marL="994136" indent="0">
              <a:buNone/>
              <a:defRPr sz="1160" b="1"/>
            </a:lvl4pPr>
            <a:lvl5pPr marL="1325514" indent="0">
              <a:buNone/>
              <a:defRPr sz="1160" b="1"/>
            </a:lvl5pPr>
            <a:lvl6pPr marL="1656893" indent="0">
              <a:buNone/>
              <a:defRPr sz="1160" b="1"/>
            </a:lvl6pPr>
            <a:lvl7pPr marL="1988271" indent="0">
              <a:buNone/>
              <a:defRPr sz="1160" b="1"/>
            </a:lvl7pPr>
            <a:lvl8pPr marL="2319650" indent="0">
              <a:buNone/>
              <a:defRPr sz="1160" b="1"/>
            </a:lvl8pPr>
            <a:lvl9pPr marL="2651028" indent="0">
              <a:buNone/>
              <a:defRPr sz="116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355331" y="3006090"/>
            <a:ext cx="2817684" cy="442150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ED039-0B3E-4935-8025-9FA77E41070A}" type="datetimeFigureOut">
              <a:rPr lang="en-US" smtClean="0"/>
              <a:t>12/5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EC0E46-4EA7-48F4-AD53-1E8331C089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4578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ED039-0B3E-4935-8025-9FA77E41070A}" type="datetimeFigureOut">
              <a:rPr lang="en-US" smtClean="0"/>
              <a:t>12/5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EC0E46-4EA7-48F4-AD53-1E8331C089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9694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ED039-0B3E-4935-8025-9FA77E41070A}" type="datetimeFigureOut">
              <a:rPr lang="en-US" smtClean="0"/>
              <a:t>12/5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EC0E46-4EA7-48F4-AD53-1E8331C089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61636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6526" y="548640"/>
            <a:ext cx="2137642" cy="1920240"/>
          </a:xfrm>
        </p:spPr>
        <p:txBody>
          <a:bodyPr anchor="b"/>
          <a:lstStyle>
            <a:lvl1pPr>
              <a:defRPr sz="2319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817684" y="1184912"/>
            <a:ext cx="3355330" cy="5848350"/>
          </a:xfrm>
        </p:spPr>
        <p:txBody>
          <a:bodyPr/>
          <a:lstStyle>
            <a:lvl1pPr>
              <a:defRPr sz="2319"/>
            </a:lvl1pPr>
            <a:lvl2pPr>
              <a:defRPr sz="2029"/>
            </a:lvl2pPr>
            <a:lvl3pPr>
              <a:defRPr sz="1740"/>
            </a:lvl3pPr>
            <a:lvl4pPr>
              <a:defRPr sz="1450"/>
            </a:lvl4pPr>
            <a:lvl5pPr>
              <a:defRPr sz="1450"/>
            </a:lvl5pPr>
            <a:lvl6pPr>
              <a:defRPr sz="1450"/>
            </a:lvl6pPr>
            <a:lvl7pPr>
              <a:defRPr sz="1450"/>
            </a:lvl7pPr>
            <a:lvl8pPr>
              <a:defRPr sz="1450"/>
            </a:lvl8pPr>
            <a:lvl9pPr>
              <a:defRPr sz="14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6526" y="2468880"/>
            <a:ext cx="2137642" cy="4573906"/>
          </a:xfrm>
        </p:spPr>
        <p:txBody>
          <a:bodyPr/>
          <a:lstStyle>
            <a:lvl1pPr marL="0" indent="0">
              <a:buNone/>
              <a:defRPr sz="1160"/>
            </a:lvl1pPr>
            <a:lvl2pPr marL="331379" indent="0">
              <a:buNone/>
              <a:defRPr sz="1015"/>
            </a:lvl2pPr>
            <a:lvl3pPr marL="662757" indent="0">
              <a:buNone/>
              <a:defRPr sz="870"/>
            </a:lvl3pPr>
            <a:lvl4pPr marL="994136" indent="0">
              <a:buNone/>
              <a:defRPr sz="725"/>
            </a:lvl4pPr>
            <a:lvl5pPr marL="1325514" indent="0">
              <a:buNone/>
              <a:defRPr sz="725"/>
            </a:lvl5pPr>
            <a:lvl6pPr marL="1656893" indent="0">
              <a:buNone/>
              <a:defRPr sz="725"/>
            </a:lvl6pPr>
            <a:lvl7pPr marL="1988271" indent="0">
              <a:buNone/>
              <a:defRPr sz="725"/>
            </a:lvl7pPr>
            <a:lvl8pPr marL="2319650" indent="0">
              <a:buNone/>
              <a:defRPr sz="725"/>
            </a:lvl8pPr>
            <a:lvl9pPr marL="2651028" indent="0">
              <a:buNone/>
              <a:defRPr sz="725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ED039-0B3E-4935-8025-9FA77E41070A}" type="datetimeFigureOut">
              <a:rPr lang="en-US" smtClean="0"/>
              <a:t>12/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EC0E46-4EA7-48F4-AD53-1E8331C089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87557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6526" y="548640"/>
            <a:ext cx="2137642" cy="1920240"/>
          </a:xfrm>
        </p:spPr>
        <p:txBody>
          <a:bodyPr anchor="b"/>
          <a:lstStyle>
            <a:lvl1pPr>
              <a:defRPr sz="2319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817684" y="1184912"/>
            <a:ext cx="3355330" cy="5848350"/>
          </a:xfrm>
        </p:spPr>
        <p:txBody>
          <a:bodyPr anchor="t"/>
          <a:lstStyle>
            <a:lvl1pPr marL="0" indent="0">
              <a:buNone/>
              <a:defRPr sz="2319"/>
            </a:lvl1pPr>
            <a:lvl2pPr marL="331379" indent="0">
              <a:buNone/>
              <a:defRPr sz="2029"/>
            </a:lvl2pPr>
            <a:lvl3pPr marL="662757" indent="0">
              <a:buNone/>
              <a:defRPr sz="1740"/>
            </a:lvl3pPr>
            <a:lvl4pPr marL="994136" indent="0">
              <a:buNone/>
              <a:defRPr sz="1450"/>
            </a:lvl4pPr>
            <a:lvl5pPr marL="1325514" indent="0">
              <a:buNone/>
              <a:defRPr sz="1450"/>
            </a:lvl5pPr>
            <a:lvl6pPr marL="1656893" indent="0">
              <a:buNone/>
              <a:defRPr sz="1450"/>
            </a:lvl6pPr>
            <a:lvl7pPr marL="1988271" indent="0">
              <a:buNone/>
              <a:defRPr sz="1450"/>
            </a:lvl7pPr>
            <a:lvl8pPr marL="2319650" indent="0">
              <a:buNone/>
              <a:defRPr sz="1450"/>
            </a:lvl8pPr>
            <a:lvl9pPr marL="2651028" indent="0">
              <a:buNone/>
              <a:defRPr sz="145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6526" y="2468880"/>
            <a:ext cx="2137642" cy="4573906"/>
          </a:xfrm>
        </p:spPr>
        <p:txBody>
          <a:bodyPr/>
          <a:lstStyle>
            <a:lvl1pPr marL="0" indent="0">
              <a:buNone/>
              <a:defRPr sz="1160"/>
            </a:lvl1pPr>
            <a:lvl2pPr marL="331379" indent="0">
              <a:buNone/>
              <a:defRPr sz="1015"/>
            </a:lvl2pPr>
            <a:lvl3pPr marL="662757" indent="0">
              <a:buNone/>
              <a:defRPr sz="870"/>
            </a:lvl3pPr>
            <a:lvl4pPr marL="994136" indent="0">
              <a:buNone/>
              <a:defRPr sz="725"/>
            </a:lvl4pPr>
            <a:lvl5pPr marL="1325514" indent="0">
              <a:buNone/>
              <a:defRPr sz="725"/>
            </a:lvl5pPr>
            <a:lvl6pPr marL="1656893" indent="0">
              <a:buNone/>
              <a:defRPr sz="725"/>
            </a:lvl6pPr>
            <a:lvl7pPr marL="1988271" indent="0">
              <a:buNone/>
              <a:defRPr sz="725"/>
            </a:lvl7pPr>
            <a:lvl8pPr marL="2319650" indent="0">
              <a:buNone/>
              <a:defRPr sz="725"/>
            </a:lvl8pPr>
            <a:lvl9pPr marL="2651028" indent="0">
              <a:buNone/>
              <a:defRPr sz="725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ED039-0B3E-4935-8025-9FA77E41070A}" type="datetimeFigureOut">
              <a:rPr lang="en-US" smtClean="0"/>
              <a:t>12/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EC0E46-4EA7-48F4-AD53-1E8331C089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69348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5662" y="438152"/>
            <a:ext cx="5716489" cy="15906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5662" y="2190750"/>
            <a:ext cx="5716489" cy="522160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5662" y="7627622"/>
            <a:ext cx="1491258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7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5ED039-0B3E-4935-8025-9FA77E41070A}" type="datetimeFigureOut">
              <a:rPr lang="en-US" smtClean="0"/>
              <a:t>12/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95463" y="7627622"/>
            <a:ext cx="2236887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7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680893" y="7627622"/>
            <a:ext cx="1491258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7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EC0E46-4EA7-48F4-AD53-1E8331C089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04423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62757" rtl="0" eaLnBrk="1" latinLnBrk="0" hangingPunct="1">
        <a:lnSpc>
          <a:spcPct val="90000"/>
        </a:lnSpc>
        <a:spcBef>
          <a:spcPct val="0"/>
        </a:spcBef>
        <a:buNone/>
        <a:defRPr sz="318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5689" indent="-165689" algn="l" defTabSz="662757" rtl="0" eaLnBrk="1" latinLnBrk="0" hangingPunct="1">
        <a:lnSpc>
          <a:spcPct val="90000"/>
        </a:lnSpc>
        <a:spcBef>
          <a:spcPts val="725"/>
        </a:spcBef>
        <a:buFont typeface="Arial" panose="020B0604020202020204" pitchFamily="34" charset="0"/>
        <a:buChar char="•"/>
        <a:defRPr sz="2029" kern="1200">
          <a:solidFill>
            <a:schemeClr val="tx1"/>
          </a:solidFill>
          <a:latin typeface="+mn-lt"/>
          <a:ea typeface="+mn-ea"/>
          <a:cs typeface="+mn-cs"/>
        </a:defRPr>
      </a:lvl1pPr>
      <a:lvl2pPr marL="497068" indent="-165689" algn="l" defTabSz="662757" rtl="0" eaLnBrk="1" latinLnBrk="0" hangingPunct="1">
        <a:lnSpc>
          <a:spcPct val="90000"/>
        </a:lnSpc>
        <a:spcBef>
          <a:spcPts val="362"/>
        </a:spcBef>
        <a:buFont typeface="Arial" panose="020B0604020202020204" pitchFamily="34" charset="0"/>
        <a:buChar char="•"/>
        <a:defRPr sz="1740" kern="1200">
          <a:solidFill>
            <a:schemeClr val="tx1"/>
          </a:solidFill>
          <a:latin typeface="+mn-lt"/>
          <a:ea typeface="+mn-ea"/>
          <a:cs typeface="+mn-cs"/>
        </a:defRPr>
      </a:lvl2pPr>
      <a:lvl3pPr marL="828446" indent="-165689" algn="l" defTabSz="662757" rtl="0" eaLnBrk="1" latinLnBrk="0" hangingPunct="1">
        <a:lnSpc>
          <a:spcPct val="90000"/>
        </a:lnSpc>
        <a:spcBef>
          <a:spcPts val="362"/>
        </a:spcBef>
        <a:buFont typeface="Arial" panose="020B0604020202020204" pitchFamily="34" charset="0"/>
        <a:buChar char="•"/>
        <a:defRPr sz="1450" kern="1200">
          <a:solidFill>
            <a:schemeClr val="tx1"/>
          </a:solidFill>
          <a:latin typeface="+mn-lt"/>
          <a:ea typeface="+mn-ea"/>
          <a:cs typeface="+mn-cs"/>
        </a:defRPr>
      </a:lvl3pPr>
      <a:lvl4pPr marL="1159825" indent="-165689" algn="l" defTabSz="662757" rtl="0" eaLnBrk="1" latinLnBrk="0" hangingPunct="1">
        <a:lnSpc>
          <a:spcPct val="90000"/>
        </a:lnSpc>
        <a:spcBef>
          <a:spcPts val="362"/>
        </a:spcBef>
        <a:buFont typeface="Arial" panose="020B0604020202020204" pitchFamily="34" charset="0"/>
        <a:buChar char="•"/>
        <a:defRPr sz="1305" kern="1200">
          <a:solidFill>
            <a:schemeClr val="tx1"/>
          </a:solidFill>
          <a:latin typeface="+mn-lt"/>
          <a:ea typeface="+mn-ea"/>
          <a:cs typeface="+mn-cs"/>
        </a:defRPr>
      </a:lvl4pPr>
      <a:lvl5pPr marL="1491204" indent="-165689" algn="l" defTabSz="662757" rtl="0" eaLnBrk="1" latinLnBrk="0" hangingPunct="1">
        <a:lnSpc>
          <a:spcPct val="90000"/>
        </a:lnSpc>
        <a:spcBef>
          <a:spcPts val="362"/>
        </a:spcBef>
        <a:buFont typeface="Arial" panose="020B0604020202020204" pitchFamily="34" charset="0"/>
        <a:buChar char="•"/>
        <a:defRPr sz="1305" kern="1200">
          <a:solidFill>
            <a:schemeClr val="tx1"/>
          </a:solidFill>
          <a:latin typeface="+mn-lt"/>
          <a:ea typeface="+mn-ea"/>
          <a:cs typeface="+mn-cs"/>
        </a:defRPr>
      </a:lvl5pPr>
      <a:lvl6pPr marL="1822582" indent="-165689" algn="l" defTabSz="662757" rtl="0" eaLnBrk="1" latinLnBrk="0" hangingPunct="1">
        <a:lnSpc>
          <a:spcPct val="90000"/>
        </a:lnSpc>
        <a:spcBef>
          <a:spcPts val="362"/>
        </a:spcBef>
        <a:buFont typeface="Arial" panose="020B0604020202020204" pitchFamily="34" charset="0"/>
        <a:buChar char="•"/>
        <a:defRPr sz="1305" kern="1200">
          <a:solidFill>
            <a:schemeClr val="tx1"/>
          </a:solidFill>
          <a:latin typeface="+mn-lt"/>
          <a:ea typeface="+mn-ea"/>
          <a:cs typeface="+mn-cs"/>
        </a:defRPr>
      </a:lvl6pPr>
      <a:lvl7pPr marL="2153961" indent="-165689" algn="l" defTabSz="662757" rtl="0" eaLnBrk="1" latinLnBrk="0" hangingPunct="1">
        <a:lnSpc>
          <a:spcPct val="90000"/>
        </a:lnSpc>
        <a:spcBef>
          <a:spcPts val="362"/>
        </a:spcBef>
        <a:buFont typeface="Arial" panose="020B0604020202020204" pitchFamily="34" charset="0"/>
        <a:buChar char="•"/>
        <a:defRPr sz="1305" kern="1200">
          <a:solidFill>
            <a:schemeClr val="tx1"/>
          </a:solidFill>
          <a:latin typeface="+mn-lt"/>
          <a:ea typeface="+mn-ea"/>
          <a:cs typeface="+mn-cs"/>
        </a:defRPr>
      </a:lvl7pPr>
      <a:lvl8pPr marL="2485339" indent="-165689" algn="l" defTabSz="662757" rtl="0" eaLnBrk="1" latinLnBrk="0" hangingPunct="1">
        <a:lnSpc>
          <a:spcPct val="90000"/>
        </a:lnSpc>
        <a:spcBef>
          <a:spcPts val="362"/>
        </a:spcBef>
        <a:buFont typeface="Arial" panose="020B0604020202020204" pitchFamily="34" charset="0"/>
        <a:buChar char="•"/>
        <a:defRPr sz="1305" kern="1200">
          <a:solidFill>
            <a:schemeClr val="tx1"/>
          </a:solidFill>
          <a:latin typeface="+mn-lt"/>
          <a:ea typeface="+mn-ea"/>
          <a:cs typeface="+mn-cs"/>
        </a:defRPr>
      </a:lvl8pPr>
      <a:lvl9pPr marL="2816718" indent="-165689" algn="l" defTabSz="662757" rtl="0" eaLnBrk="1" latinLnBrk="0" hangingPunct="1">
        <a:lnSpc>
          <a:spcPct val="90000"/>
        </a:lnSpc>
        <a:spcBef>
          <a:spcPts val="362"/>
        </a:spcBef>
        <a:buFont typeface="Arial" panose="020B0604020202020204" pitchFamily="34" charset="0"/>
        <a:buChar char="•"/>
        <a:defRPr sz="130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62757" rtl="0" eaLnBrk="1" latinLnBrk="0" hangingPunct="1">
        <a:defRPr sz="1305" kern="1200">
          <a:solidFill>
            <a:schemeClr val="tx1"/>
          </a:solidFill>
          <a:latin typeface="+mn-lt"/>
          <a:ea typeface="+mn-ea"/>
          <a:cs typeface="+mn-cs"/>
        </a:defRPr>
      </a:lvl1pPr>
      <a:lvl2pPr marL="331379" algn="l" defTabSz="662757" rtl="0" eaLnBrk="1" latinLnBrk="0" hangingPunct="1">
        <a:defRPr sz="1305" kern="1200">
          <a:solidFill>
            <a:schemeClr val="tx1"/>
          </a:solidFill>
          <a:latin typeface="+mn-lt"/>
          <a:ea typeface="+mn-ea"/>
          <a:cs typeface="+mn-cs"/>
        </a:defRPr>
      </a:lvl2pPr>
      <a:lvl3pPr marL="662757" algn="l" defTabSz="662757" rtl="0" eaLnBrk="1" latinLnBrk="0" hangingPunct="1">
        <a:defRPr sz="1305" kern="1200">
          <a:solidFill>
            <a:schemeClr val="tx1"/>
          </a:solidFill>
          <a:latin typeface="+mn-lt"/>
          <a:ea typeface="+mn-ea"/>
          <a:cs typeface="+mn-cs"/>
        </a:defRPr>
      </a:lvl3pPr>
      <a:lvl4pPr marL="994136" algn="l" defTabSz="662757" rtl="0" eaLnBrk="1" latinLnBrk="0" hangingPunct="1">
        <a:defRPr sz="1305" kern="1200">
          <a:solidFill>
            <a:schemeClr val="tx1"/>
          </a:solidFill>
          <a:latin typeface="+mn-lt"/>
          <a:ea typeface="+mn-ea"/>
          <a:cs typeface="+mn-cs"/>
        </a:defRPr>
      </a:lvl4pPr>
      <a:lvl5pPr marL="1325514" algn="l" defTabSz="662757" rtl="0" eaLnBrk="1" latinLnBrk="0" hangingPunct="1">
        <a:defRPr sz="1305" kern="1200">
          <a:solidFill>
            <a:schemeClr val="tx1"/>
          </a:solidFill>
          <a:latin typeface="+mn-lt"/>
          <a:ea typeface="+mn-ea"/>
          <a:cs typeface="+mn-cs"/>
        </a:defRPr>
      </a:lvl5pPr>
      <a:lvl6pPr marL="1656893" algn="l" defTabSz="662757" rtl="0" eaLnBrk="1" latinLnBrk="0" hangingPunct="1">
        <a:defRPr sz="1305" kern="1200">
          <a:solidFill>
            <a:schemeClr val="tx1"/>
          </a:solidFill>
          <a:latin typeface="+mn-lt"/>
          <a:ea typeface="+mn-ea"/>
          <a:cs typeface="+mn-cs"/>
        </a:defRPr>
      </a:lvl6pPr>
      <a:lvl7pPr marL="1988271" algn="l" defTabSz="662757" rtl="0" eaLnBrk="1" latinLnBrk="0" hangingPunct="1">
        <a:defRPr sz="1305" kern="1200">
          <a:solidFill>
            <a:schemeClr val="tx1"/>
          </a:solidFill>
          <a:latin typeface="+mn-lt"/>
          <a:ea typeface="+mn-ea"/>
          <a:cs typeface="+mn-cs"/>
        </a:defRPr>
      </a:lvl7pPr>
      <a:lvl8pPr marL="2319650" algn="l" defTabSz="662757" rtl="0" eaLnBrk="1" latinLnBrk="0" hangingPunct="1">
        <a:defRPr sz="1305" kern="1200">
          <a:solidFill>
            <a:schemeClr val="tx1"/>
          </a:solidFill>
          <a:latin typeface="+mn-lt"/>
          <a:ea typeface="+mn-ea"/>
          <a:cs typeface="+mn-cs"/>
        </a:defRPr>
      </a:lvl8pPr>
      <a:lvl9pPr marL="2651028" algn="l" defTabSz="662757" rtl="0" eaLnBrk="1" latinLnBrk="0" hangingPunct="1">
        <a:defRPr sz="130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コンテンツ プレースホルダー 3"/>
          <p:cNvPicPr>
            <a:picLocks noGrp="1" noChangeAspect="1"/>
          </p:cNvPicPr>
          <p:nvPr>
            <p:ph idx="1"/>
          </p:nvPr>
        </p:nvPicPr>
        <p:blipFill rotWithShape="1">
          <a:blip r:embed="rId2"/>
          <a:srcRect l="4882" t="35489" r="67949" b="41235"/>
          <a:stretch/>
        </p:blipFill>
        <p:spPr>
          <a:xfrm>
            <a:off x="0" y="1465078"/>
            <a:ext cx="1810176" cy="1145489"/>
          </a:xfrm>
          <a:prstGeom prst="rect">
            <a:avLst/>
          </a:prstGeom>
        </p:spPr>
      </p:pic>
      <p:sp>
        <p:nvSpPr>
          <p:cNvPr id="5" name="右矢印 4"/>
          <p:cNvSpPr/>
          <p:nvPr/>
        </p:nvSpPr>
        <p:spPr>
          <a:xfrm>
            <a:off x="4517940" y="1790602"/>
            <a:ext cx="876752" cy="450166"/>
          </a:xfrm>
          <a:prstGeom prst="right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テキスト ボックス 4"/>
          <p:cNvSpPr txBox="1">
            <a:spLocks noChangeArrowheads="1"/>
          </p:cNvSpPr>
          <p:nvPr/>
        </p:nvSpPr>
        <p:spPr bwMode="auto">
          <a:xfrm>
            <a:off x="27317" y="974486"/>
            <a:ext cx="1782859" cy="5847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/>
        </p:spPr>
        <p:txBody>
          <a:bodyPr wrap="non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/>
            <a:r>
              <a:rPr lang="en-US" altLang="ja-JP" sz="16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CPC-APC mouse</a:t>
            </a:r>
          </a:p>
          <a:p>
            <a:pPr algn="ctr" eaLnBrk="1" hangingPunct="1"/>
            <a:r>
              <a:rPr lang="en-US" altLang="ja-JP" sz="16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8weeks</a:t>
            </a:r>
            <a:endParaRPr lang="ja-JP" altLang="en-US" sz="16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8" name="テキスト ボックス 4"/>
          <p:cNvSpPr txBox="1">
            <a:spLocks noChangeArrowheads="1"/>
          </p:cNvSpPr>
          <p:nvPr/>
        </p:nvSpPr>
        <p:spPr bwMode="auto">
          <a:xfrm>
            <a:off x="-71459" y="2964310"/>
            <a:ext cx="3195105" cy="5847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/>
        </p:spPr>
        <p:txBody>
          <a:bodyPr wrap="non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/>
            <a:r>
              <a:rPr lang="ja-JP" altLang="en-US" sz="16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①</a:t>
            </a:r>
            <a:r>
              <a:rPr lang="en-US" altLang="ja-JP" sz="16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Isotype control Ab, </a:t>
            </a:r>
            <a:r>
              <a:rPr lang="en-US" altLang="ja-JP" sz="1600" dirty="0" err="1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i.p</a:t>
            </a:r>
            <a:r>
              <a:rPr lang="en-US" altLang="ja-JP" sz="16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,</a:t>
            </a:r>
            <a:r>
              <a:rPr lang="en-US" altLang="ja-JP" sz="16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 weekly </a:t>
            </a:r>
          </a:p>
          <a:p>
            <a:pPr eaLnBrk="1" hangingPunct="1"/>
            <a:r>
              <a:rPr lang="ja-JP" altLang="en-US" sz="16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②</a:t>
            </a:r>
            <a:r>
              <a:rPr lang="en-US" altLang="ja-JP" sz="16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Anti-</a:t>
            </a:r>
            <a:r>
              <a:rPr lang="en-US" altLang="ja-JP" sz="1600" dirty="0" err="1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SIRPa</a:t>
            </a:r>
            <a:r>
              <a:rPr lang="en-US" altLang="ja-JP" sz="16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 </a:t>
            </a:r>
            <a:r>
              <a:rPr lang="en-US" altLang="ja-JP" sz="1600" dirty="0" err="1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mAb</a:t>
            </a:r>
            <a:r>
              <a:rPr lang="en-US" altLang="ja-JP" sz="16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, </a:t>
            </a:r>
            <a:r>
              <a:rPr lang="en-US" altLang="ja-JP" sz="1600" dirty="0" err="1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i.p</a:t>
            </a:r>
            <a:r>
              <a:rPr lang="en-US" altLang="ja-JP" sz="16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, weekly </a:t>
            </a:r>
            <a:endParaRPr lang="ja-JP" altLang="en-US" sz="16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9" name="テキスト ボックス 4"/>
          <p:cNvSpPr txBox="1">
            <a:spLocks noChangeArrowheads="1"/>
          </p:cNvSpPr>
          <p:nvPr/>
        </p:nvSpPr>
        <p:spPr bwMode="auto">
          <a:xfrm>
            <a:off x="2738572" y="1745434"/>
            <a:ext cx="1755143" cy="5847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/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/>
            <a:r>
              <a:rPr lang="en-US" altLang="ja-JP" sz="16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C</a:t>
            </a:r>
            <a:r>
              <a:rPr lang="en-US" altLang="ja-JP" sz="16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olon fiber on every 4 weeks</a:t>
            </a:r>
            <a:endParaRPr lang="ja-JP" altLang="en-US" sz="16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10" name="テキスト ボックス 4"/>
          <p:cNvSpPr txBox="1">
            <a:spLocks noChangeArrowheads="1"/>
          </p:cNvSpPr>
          <p:nvPr/>
        </p:nvSpPr>
        <p:spPr bwMode="auto">
          <a:xfrm>
            <a:off x="5283206" y="1720956"/>
            <a:ext cx="1503032" cy="83099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/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/>
            <a:r>
              <a:rPr lang="en-US" altLang="ja-JP" sz="16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Analyze survival time</a:t>
            </a:r>
          </a:p>
          <a:p>
            <a:pPr algn="ctr" eaLnBrk="1" hangingPunct="1"/>
            <a:r>
              <a:rPr lang="en-US" altLang="ja-JP" sz="16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(</a:t>
            </a:r>
            <a:r>
              <a:rPr lang="en-US" altLang="ja-JP" sz="16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n=5)</a:t>
            </a:r>
            <a:endParaRPr lang="ja-JP" altLang="en-US" sz="16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11" name="右矢印 10"/>
          <p:cNvSpPr/>
          <p:nvPr/>
        </p:nvSpPr>
        <p:spPr>
          <a:xfrm rot="16200000">
            <a:off x="676406" y="2587678"/>
            <a:ext cx="484682" cy="208535"/>
          </a:xfrm>
          <a:prstGeom prst="right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右矢印 11"/>
          <p:cNvSpPr/>
          <p:nvPr/>
        </p:nvSpPr>
        <p:spPr>
          <a:xfrm>
            <a:off x="1873481" y="1788261"/>
            <a:ext cx="876752" cy="450166"/>
          </a:xfrm>
          <a:prstGeom prst="right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テキスト ボックス 4"/>
          <p:cNvSpPr txBox="1">
            <a:spLocks noChangeArrowheads="1"/>
          </p:cNvSpPr>
          <p:nvPr/>
        </p:nvSpPr>
        <p:spPr bwMode="auto">
          <a:xfrm>
            <a:off x="4125744" y="1218025"/>
            <a:ext cx="1503032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/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/>
            <a:r>
              <a:rPr lang="en-US" altLang="ja-JP" sz="16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20wks  </a:t>
            </a:r>
            <a:endParaRPr lang="en-US" altLang="ja-JP" sz="1600" dirty="0" smtClean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16" name="テキスト ボックス 4"/>
          <p:cNvSpPr txBox="1">
            <a:spLocks noChangeArrowheads="1"/>
          </p:cNvSpPr>
          <p:nvPr/>
        </p:nvSpPr>
        <p:spPr bwMode="auto">
          <a:xfrm>
            <a:off x="3463469" y="2973610"/>
            <a:ext cx="2865245" cy="5847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/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/>
            <a:r>
              <a:rPr lang="en-US" altLang="ja-JP" sz="16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A</a:t>
            </a:r>
            <a:r>
              <a:rPr lang="en-US" altLang="ja-JP" sz="16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nalyze tumor and tumor infiltrated macrophages (n=6)</a:t>
            </a:r>
            <a:endParaRPr lang="ja-JP" altLang="en-US" sz="16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17" name="右矢印 16"/>
          <p:cNvSpPr/>
          <p:nvPr/>
        </p:nvSpPr>
        <p:spPr>
          <a:xfrm rot="5400000">
            <a:off x="4634918" y="2587678"/>
            <a:ext cx="484682" cy="208535"/>
          </a:xfrm>
          <a:prstGeom prst="right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65689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0526</TotalTime>
  <Words>40</Words>
  <Application>Microsoft Office PowerPoint</Application>
  <PresentationFormat>ユーザー設定</PresentationFormat>
  <Paragraphs>9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Arial Unicode MS</vt:lpstr>
      <vt:lpstr>ＭＳ Ｐ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anuki</dc:creator>
  <cp:lastModifiedBy>Sanuki</cp:lastModifiedBy>
  <cp:revision>395</cp:revision>
  <cp:lastPrinted>2017-05-16T06:38:32Z</cp:lastPrinted>
  <dcterms:created xsi:type="dcterms:W3CDTF">2014-04-30T02:57:16Z</dcterms:created>
  <dcterms:modified xsi:type="dcterms:W3CDTF">2017-12-05T13:48:27Z</dcterms:modified>
</cp:coreProperties>
</file>